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64" r:id="rId4"/>
    <p:sldId id="263" r:id="rId5"/>
    <p:sldId id="265" r:id="rId6"/>
    <p:sldId id="257" r:id="rId7"/>
    <p:sldId id="267" r:id="rId8"/>
    <p:sldId id="258" r:id="rId9"/>
    <p:sldId id="268" r:id="rId10"/>
    <p:sldId id="269" r:id="rId11"/>
    <p:sldId id="261" r:id="rId12"/>
    <p:sldId id="262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\OneDrive\Desktop\2020%20Essentials\NG2020%20CaDrivers\460%20Cancer%20Driver%20Gene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cap="none" spc="2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solidFill>
                  <a:schemeClr val="tx1"/>
                </a:solidFill>
              </a:rPr>
              <a:t>Direct</a:t>
            </a:r>
            <a:r>
              <a:rPr lang="en-US" sz="1600" b="1" baseline="0">
                <a:solidFill>
                  <a:schemeClr val="tx1"/>
                </a:solidFill>
              </a:rPr>
              <a:t> correlation between n</a:t>
            </a:r>
            <a:r>
              <a:rPr lang="en-US" sz="1600" b="1">
                <a:solidFill>
                  <a:schemeClr val="tx1"/>
                </a:solidFill>
              </a:rPr>
              <a:t>umbers of SCARS-activated and SCARS-silenced cancer driver genes in 28 human cancer type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cap="none" spc="2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283603112660773"/>
          <c:y val="0.11525572616100541"/>
          <c:w val="0.86434871960653026"/>
          <c:h val="0.7369986931570613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5!$R$2</c:f>
              <c:strCache>
                <c:ptCount val="1"/>
                <c:pt idx="0">
                  <c:v>Number of SCARS-activated cancer driver genes</c:v>
                </c:pt>
              </c:strCache>
            </c:strRef>
          </c:tx>
          <c:spPr>
            <a:ln w="25400" cap="flat" cmpd="sng" algn="ctr">
              <a:noFill/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38100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49329704204862956"/>
                  <c:y val="-8.5697485491754305E-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600" b="1" i="0" u="none" strike="noStrike" kern="1200" baseline="0">
                      <a:solidFill>
                        <a:sysClr val="windowText" lastClr="0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5!$Q$3:$Q$30</c:f>
              <c:numCache>
                <c:formatCode>General</c:formatCode>
                <c:ptCount val="28"/>
                <c:pt idx="0">
                  <c:v>2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9</c:v>
                </c:pt>
                <c:pt idx="6">
                  <c:v>7</c:v>
                </c:pt>
                <c:pt idx="7">
                  <c:v>7</c:v>
                </c:pt>
                <c:pt idx="8">
                  <c:v>8</c:v>
                </c:pt>
                <c:pt idx="9">
                  <c:v>8</c:v>
                </c:pt>
                <c:pt idx="10">
                  <c:v>8</c:v>
                </c:pt>
                <c:pt idx="11">
                  <c:v>11</c:v>
                </c:pt>
                <c:pt idx="12">
                  <c:v>12</c:v>
                </c:pt>
                <c:pt idx="13">
                  <c:v>14</c:v>
                </c:pt>
                <c:pt idx="14">
                  <c:v>15</c:v>
                </c:pt>
                <c:pt idx="15">
                  <c:v>19</c:v>
                </c:pt>
                <c:pt idx="16">
                  <c:v>16</c:v>
                </c:pt>
                <c:pt idx="17">
                  <c:v>18</c:v>
                </c:pt>
                <c:pt idx="18">
                  <c:v>19</c:v>
                </c:pt>
                <c:pt idx="19">
                  <c:v>21</c:v>
                </c:pt>
                <c:pt idx="20">
                  <c:v>22</c:v>
                </c:pt>
                <c:pt idx="21">
                  <c:v>28</c:v>
                </c:pt>
                <c:pt idx="22">
                  <c:v>28</c:v>
                </c:pt>
                <c:pt idx="23">
                  <c:v>30</c:v>
                </c:pt>
                <c:pt idx="24">
                  <c:v>25</c:v>
                </c:pt>
                <c:pt idx="25">
                  <c:v>30</c:v>
                </c:pt>
                <c:pt idx="26">
                  <c:v>36</c:v>
                </c:pt>
                <c:pt idx="27">
                  <c:v>37</c:v>
                </c:pt>
              </c:numCache>
            </c:numRef>
          </c:xVal>
          <c:yVal>
            <c:numRef>
              <c:f>Sheet5!$R$3:$R$30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3</c:v>
                </c:pt>
                <c:pt idx="4">
                  <c:v>2</c:v>
                </c:pt>
                <c:pt idx="5">
                  <c:v>0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9</c:v>
                </c:pt>
                <c:pt idx="11">
                  <c:v>8</c:v>
                </c:pt>
                <c:pt idx="12">
                  <c:v>8</c:v>
                </c:pt>
                <c:pt idx="13">
                  <c:v>6</c:v>
                </c:pt>
                <c:pt idx="14">
                  <c:v>9</c:v>
                </c:pt>
                <c:pt idx="15">
                  <c:v>6</c:v>
                </c:pt>
                <c:pt idx="16">
                  <c:v>12</c:v>
                </c:pt>
                <c:pt idx="17">
                  <c:v>10</c:v>
                </c:pt>
                <c:pt idx="18">
                  <c:v>11</c:v>
                </c:pt>
                <c:pt idx="19">
                  <c:v>13</c:v>
                </c:pt>
                <c:pt idx="20">
                  <c:v>17</c:v>
                </c:pt>
                <c:pt idx="21">
                  <c:v>16</c:v>
                </c:pt>
                <c:pt idx="22">
                  <c:v>17</c:v>
                </c:pt>
                <c:pt idx="23">
                  <c:v>16</c:v>
                </c:pt>
                <c:pt idx="24">
                  <c:v>22</c:v>
                </c:pt>
                <c:pt idx="25">
                  <c:v>20</c:v>
                </c:pt>
                <c:pt idx="26">
                  <c:v>25</c:v>
                </c:pt>
                <c:pt idx="27">
                  <c:v>2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9868544"/>
        <c:axId val="359871680"/>
      </c:scatterChart>
      <c:valAx>
        <c:axId val="3598685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</a:rPr>
                  <a:t>Number</a:t>
                </a:r>
                <a:r>
                  <a:rPr lang="en-US" sz="1600" b="1" baseline="0">
                    <a:solidFill>
                      <a:sysClr val="windowText" lastClr="000000"/>
                    </a:solidFill>
                  </a:rPr>
                  <a:t> of SCARS-silenced cancer driver genes</a:t>
                </a:r>
                <a:endParaRPr lang="en-US" sz="16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.32012769298265875"/>
              <c:y val="0.917257655030025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rnd">
            <a:solidFill>
              <a:schemeClr val="dk1">
                <a:lumMod val="20000"/>
                <a:lumOff val="8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9871680"/>
        <c:crosses val="autoZero"/>
        <c:crossBetween val="midCat"/>
      </c:valAx>
      <c:valAx>
        <c:axId val="3598716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ysClr val="windowText" lastClr="000000"/>
                    </a:solidFill>
                  </a:rPr>
                  <a:t>Number</a:t>
                </a:r>
                <a:r>
                  <a:rPr lang="en-US" sz="1600" b="1" baseline="0">
                    <a:solidFill>
                      <a:sysClr val="windowText" lastClr="000000"/>
                    </a:solidFill>
                  </a:rPr>
                  <a:t> of SCARS-activated cancer driver genes</a:t>
                </a:r>
                <a:endParaRPr lang="en-US" sz="16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0527859237536656E-2"/>
              <c:y val="0.146443506662896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9868544"/>
        <c:crosses val="autoZero"/>
        <c:crossBetween val="midCat"/>
      </c:valAx>
      <c:spPr>
        <a:gradFill>
          <a:gsLst>
            <a:gs pos="100000">
              <a:schemeClr val="lt1">
                <a:lumMod val="95000"/>
              </a:schemeClr>
            </a:gs>
            <a:gs pos="0">
              <a:schemeClr val="lt1">
                <a:alpha val="0"/>
              </a:schemeClr>
            </a:gs>
          </a:gsLst>
          <a:lin ang="5400000" scaled="0"/>
        </a:gradFill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/>
    <cs:effectRef idx="1"/>
    <cs:fontRef idx="minor">
      <a:schemeClr val="dk1"/>
    </cs:fontRef>
    <cs:spPr>
      <a:ln w="9525" cap="flat" cmpd="sng" algn="ctr">
        <a:solidFill>
          <a:schemeClr val="phClr">
            <a:alpha val="70000"/>
          </a:schemeClr>
        </a:solidFill>
        <a:prstDash val="sysDot"/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rnd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 spc="0" baseline="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>
              <a:alpha val="0"/>
            </a:schemeClr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5000"/>
            <a:lumOff val="75000"/>
          </a:schemeClr>
        </a:solidFill>
        <a:round/>
      </a:ln>
    </cs:spPr>
    <cs:defRPr sz="900" kern="1200" spc="0" baseline="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393</cdr:x>
      <cdr:y>0.29071</cdr:y>
    </cdr:from>
    <cdr:to>
      <cdr:x>0.3695</cdr:x>
      <cdr:y>0.3485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286000" y="1828801"/>
          <a:ext cx="914400" cy="3640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1">
              <a:solidFill>
                <a:sysClr val="windowText" lastClr="000000"/>
              </a:solidFill>
            </a:rPr>
            <a:t>r = 0.941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207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206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0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930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335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368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263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821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257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22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432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545856-0D3A-48E3-9DA0-9A970F044627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CE9DC-9CB5-41BB-AC4B-D4B8A51E0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011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0166" y="862642"/>
            <a:ext cx="11757804" cy="3104522"/>
          </a:xfrm>
        </p:spPr>
        <p:txBody>
          <a:bodyPr>
            <a:normAutofit fontScale="90000"/>
          </a:bodyPr>
          <a:lstStyle/>
          <a:p>
            <a:r>
              <a:rPr lang="en-US" b="1" dirty="0" smtClean="0"/>
              <a:t>Supplemental Note S4. </a:t>
            </a:r>
            <a:r>
              <a:rPr lang="en-US" dirty="0" smtClean="0"/>
              <a:t>HSRS and SCARS regulate expression of a vast majority of cancer survival predictor genes and cancer driver gen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50148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3369798"/>
              </p:ext>
            </p:extLst>
          </p:nvPr>
        </p:nvGraphicFramePr>
        <p:xfrm>
          <a:off x="457200" y="646331"/>
          <a:ext cx="11266097" cy="60308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82287"/>
                <a:gridCol w="4183810"/>
              </a:tblGrid>
              <a:tr h="2569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ancer Typ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Number of SCARS-silenced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AdenoidCysti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3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loo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2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ra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2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rea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2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ervix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Cholangio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olorec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Endometriu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3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Gastroesophage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HeadNec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KidneyClea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KidneyNonClea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Liv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Lung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LungS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Lymph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Ovaria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ancrea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Pheochromocytom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leur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rostat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Sarcom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Sk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TesticularGermCel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Thymu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Thyro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1370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UvealMelanom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  <a:tr h="256969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umber of actionable cancer therapy-guiding nodes defined by the SCARS </a:t>
                      </a:r>
                      <a:r>
                        <a:rPr lang="en-US" sz="1600" b="1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emness</a:t>
                      </a:r>
                      <a:r>
                        <a:rPr lang="en-US" sz="16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atrix mapped to connect Cancer Driver Gene/Cancer Type/Regulatory SCARS</a:t>
                      </a:r>
                      <a:endParaRPr lang="en-US" sz="1400" b="1" i="0" u="none" strike="noStrike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1365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0" marR="5710" marT="5710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520460" y="0"/>
            <a:ext cx="112028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SCARS-guided cancer </a:t>
            </a:r>
            <a:r>
              <a:rPr lang="en-US" b="1" dirty="0" err="1"/>
              <a:t>stemness</a:t>
            </a:r>
            <a:r>
              <a:rPr lang="en-US" b="1" dirty="0"/>
              <a:t> matrix of diagnostic and therapeutic targets comprising of 237 SCARS-down-regulated cancer driver genes mapped to 27 cancer types</a:t>
            </a:r>
          </a:p>
        </p:txBody>
      </p:sp>
    </p:spTree>
    <p:extLst>
      <p:ext uri="{BB962C8B-B14F-4D97-AF65-F5344CB8AC3E}">
        <p14:creationId xmlns:p14="http://schemas.microsoft.com/office/powerpoint/2010/main" val="347005982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7255112"/>
              </p:ext>
            </p:extLst>
          </p:nvPr>
        </p:nvGraphicFramePr>
        <p:xfrm>
          <a:off x="293296" y="2743504"/>
          <a:ext cx="11654287" cy="15011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42950"/>
                <a:gridCol w="1881300"/>
                <a:gridCol w="977708"/>
                <a:gridCol w="1652329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ostulated </a:t>
                      </a:r>
                      <a:r>
                        <a:rPr lang="en-US" sz="1600" b="1" u="none" strike="noStrike" dirty="0" smtClean="0">
                          <a:effectLst/>
                        </a:rPr>
                        <a:t>epigenetic states of distinct SCARS-regulated </a:t>
                      </a:r>
                      <a:r>
                        <a:rPr lang="en-US" sz="1600" b="1" u="none" strike="noStrike" dirty="0">
                          <a:effectLst/>
                        </a:rPr>
                        <a:t>cancer </a:t>
                      </a:r>
                      <a:r>
                        <a:rPr lang="en-US" sz="1600" b="1" u="none" strike="noStrike" dirty="0" err="1">
                          <a:effectLst/>
                        </a:rPr>
                        <a:t>stemness</a:t>
                      </a:r>
                      <a:r>
                        <a:rPr lang="en-US" sz="1600" b="1" u="none" strike="noStrike" dirty="0">
                          <a:effectLst/>
                        </a:rPr>
                        <a:t> pathways in cancer stem cell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Number of </a:t>
                      </a:r>
                      <a:r>
                        <a:rPr lang="en-US" sz="1600" b="1" u="none" strike="noStrike" dirty="0" smtClean="0">
                          <a:effectLst/>
                        </a:rPr>
                        <a:t>cancer driver gene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Percent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Likelihood of occurrence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CARS </a:t>
                      </a:r>
                      <a:r>
                        <a:rPr lang="en-US" sz="1600" b="1" u="none" strike="noStrike" dirty="0" smtClean="0">
                          <a:effectLst/>
                        </a:rPr>
                        <a:t>pathways </a:t>
                      </a:r>
                      <a:r>
                        <a:rPr lang="en-US" sz="1600" b="1" u="none" strike="noStrike" dirty="0">
                          <a:effectLst/>
                        </a:rPr>
                        <a:t>with transcriptionally silent cancer driver mutation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6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53.7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35.6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CARS </a:t>
                      </a:r>
                      <a:r>
                        <a:rPr lang="en-US" sz="1600" b="1" u="none" strike="noStrike" dirty="0" smtClean="0">
                          <a:effectLst/>
                        </a:rPr>
                        <a:t>pathways </a:t>
                      </a:r>
                      <a:r>
                        <a:rPr lang="en-US" sz="1600" b="1" u="none" strike="noStrike" dirty="0">
                          <a:effectLst/>
                        </a:rPr>
                        <a:t>with transcriptionally active cancer driver mutation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6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2.3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4.7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CARS </a:t>
                      </a:r>
                      <a:r>
                        <a:rPr lang="en-US" sz="1600" b="1" u="none" strike="noStrike" dirty="0" smtClean="0">
                          <a:effectLst/>
                        </a:rPr>
                        <a:t>pathways </a:t>
                      </a:r>
                      <a:r>
                        <a:rPr lang="en-US" sz="1600" b="1" u="none" strike="noStrike" dirty="0">
                          <a:effectLst/>
                        </a:rPr>
                        <a:t>with both  transcriptionally active &amp; silent cancer driver mutation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3.9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5.8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All SCARS-regulated cancer driver gene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30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00.0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66.30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93295" y="2001329"/>
            <a:ext cx="1165428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/>
              <a:t>Epigenetically-distinct </a:t>
            </a:r>
            <a:r>
              <a:rPr lang="en-US" b="1" dirty="0"/>
              <a:t>cancer </a:t>
            </a:r>
            <a:r>
              <a:rPr lang="en-US" b="1" dirty="0" err="1"/>
              <a:t>stemness</a:t>
            </a:r>
            <a:r>
              <a:rPr lang="en-US" b="1" dirty="0"/>
              <a:t> pathways in cancer stem cells defined by transcriptional status of </a:t>
            </a:r>
            <a:endParaRPr lang="en-US" b="1" dirty="0" smtClean="0"/>
          </a:p>
          <a:p>
            <a:pPr algn="ctr"/>
            <a:r>
              <a:rPr lang="en-US" b="1" dirty="0" smtClean="0"/>
              <a:t>SCARS-regulated </a:t>
            </a:r>
            <a:r>
              <a:rPr lang="en-US" b="1" dirty="0"/>
              <a:t>cancer driver genes</a:t>
            </a:r>
          </a:p>
        </p:txBody>
      </p:sp>
    </p:spTree>
    <p:extLst>
      <p:ext uri="{BB962C8B-B14F-4D97-AF65-F5344CB8AC3E}">
        <p14:creationId xmlns:p14="http://schemas.microsoft.com/office/powerpoint/2010/main" val="209525497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/>
          </p:nvPr>
        </p:nvGraphicFramePr>
        <p:xfrm>
          <a:off x="1765300" y="283633"/>
          <a:ext cx="8661400" cy="6290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51748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0166" y="1122363"/>
            <a:ext cx="11757804" cy="2387600"/>
          </a:xfrm>
        </p:spPr>
        <p:txBody>
          <a:bodyPr>
            <a:normAutofit/>
          </a:bodyPr>
          <a:lstStyle/>
          <a:p>
            <a:r>
              <a:rPr lang="en-US" dirty="0" smtClean="0"/>
              <a:t>HSRS and SCARS regulate expression of cancer survival predictor gene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57068" y="4249020"/>
            <a:ext cx="9144000" cy="1228754"/>
          </a:xfrm>
        </p:spPr>
        <p:txBody>
          <a:bodyPr/>
          <a:lstStyle/>
          <a:p>
            <a:r>
              <a:rPr lang="en-US" dirty="0" smtClean="0"/>
              <a:t>10,713 CANCER SURVIVAL PREDICTIOR GENES</a:t>
            </a:r>
          </a:p>
          <a:p>
            <a:r>
              <a:rPr lang="en-US" dirty="0" err="1"/>
              <a:t>Uhlen</a:t>
            </a:r>
            <a:r>
              <a:rPr lang="en-US" dirty="0"/>
              <a:t> M et al. 2017. A pathology atlas of the human cancer transcriptome. Science 357, 660. </a:t>
            </a:r>
          </a:p>
        </p:txBody>
      </p:sp>
    </p:spTree>
    <p:extLst>
      <p:ext uri="{BB962C8B-B14F-4D97-AF65-F5344CB8AC3E}">
        <p14:creationId xmlns:p14="http://schemas.microsoft.com/office/powerpoint/2010/main" val="816427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3115410"/>
              </p:ext>
            </p:extLst>
          </p:nvPr>
        </p:nvGraphicFramePr>
        <p:xfrm>
          <a:off x="345058" y="2190750"/>
          <a:ext cx="11421372" cy="22631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863504"/>
                <a:gridCol w="1477746"/>
                <a:gridCol w="1905046"/>
                <a:gridCol w="1299704"/>
                <a:gridCol w="1916935"/>
                <a:gridCol w="958437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fication </a:t>
                      </a:r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</a:p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protein-coding genes within a network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cancer survival genes within </a:t>
                      </a:r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networ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 of all genes within a network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 of all cancer survival genes within a network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richment P valu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cancer survival predicto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ME-iPEC network of human embry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8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0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E-30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ME-iMPC network of human embry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9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9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2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VH/LBP9 pathway of human ES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9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7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E-5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 expression in human DLPFC network 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5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1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E-19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 expression in naïve vs primed </a:t>
                      </a:r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SC 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twor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6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8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tal/Adult neocortex network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2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4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7E-7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cancer survival genes </a:t>
                      </a:r>
                      <a:r>
                        <a:rPr lang="en-US" sz="12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ociated 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HSRS network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0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345058" y="1821418"/>
            <a:ext cx="1142137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/>
              <a:t>HSRS-associated networks represent the putative </a:t>
            </a:r>
            <a:r>
              <a:rPr lang="en-US" b="1" dirty="0" err="1" smtClean="0"/>
              <a:t>pathogenetic</a:t>
            </a:r>
            <a:r>
              <a:rPr lang="en-US" b="1" dirty="0" smtClean="0"/>
              <a:t> origin of essentially all cancer survival genes</a:t>
            </a:r>
            <a:endParaRPr lang="en-US" b="1" dirty="0"/>
          </a:p>
        </p:txBody>
      </p:sp>
      <p:sp>
        <p:nvSpPr>
          <p:cNvPr id="4" name="Rectangle 3"/>
          <p:cNvSpPr/>
          <p:nvPr/>
        </p:nvSpPr>
        <p:spPr>
          <a:xfrm>
            <a:off x="345058" y="4453890"/>
            <a:ext cx="114213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Legend: TE, transposable elements; HERVH, human endogenous retrovirus type H; LBP9 (TFCP2L1), pluripotency transcription factor; DLPFC, dorsolateral prefrontal cortex; MLME, multiple lineages markers expression;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0047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51493" y="301431"/>
            <a:ext cx="7306576" cy="6477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</a:rPr>
              <a:t>Association of </a:t>
            </a:r>
            <a:r>
              <a:rPr lang="en-US" b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disease type-specific human 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</a:rPr>
              <a:t>cancer survival predictor genes with human-specific genomic regulatory sequences (HSGRS)</a:t>
            </a:r>
            <a:r>
              <a:rPr lang="en-US" b="1" dirty="0"/>
              <a:t> 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6793989"/>
              </p:ext>
            </p:extLst>
          </p:nvPr>
        </p:nvGraphicFramePr>
        <p:xfrm>
          <a:off x="2268744" y="949131"/>
          <a:ext cx="7306576" cy="50086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26644"/>
                <a:gridCol w="1826644"/>
                <a:gridCol w="2574987"/>
                <a:gridCol w="1078301"/>
              </a:tblGrid>
              <a:tr h="1878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Cancer type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All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Associated with HSGR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Percent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Thyroid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34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6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7.5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Gliom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7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0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6.0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2615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Melanom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0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5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4.6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2615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Head and neck 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80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59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3.8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Colorectal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60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44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2.9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Renal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607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441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2.7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Ovarian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50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36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2.6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Liver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89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08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2.1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Lung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66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47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2.0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Breast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58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41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1.1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Urothelial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10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8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1.1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Stomach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30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21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1.0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Prostate 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6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1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0.8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2615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Endometrial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63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15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0.6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Cervical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1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50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0.4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Pancreatic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54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07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69.4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1013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Testi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6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4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0.0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  <a:tr h="2495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All human cancer survival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1071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</a:rPr>
                        <a:t>773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72.23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40" marR="6940" marT="694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92143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1638738"/>
              </p:ext>
            </p:extLst>
          </p:nvPr>
        </p:nvGraphicFramePr>
        <p:xfrm>
          <a:off x="1173193" y="2357587"/>
          <a:ext cx="9558067" cy="12573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88386"/>
                <a:gridCol w="3030374"/>
                <a:gridCol w="2039307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fication category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VH lncRNA-regulated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0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7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TR7Y/B enhancers-regulated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40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9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TR5_Hs/SVA_D enhancers-regulated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6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SCARS-regulated HSRS-associated genes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8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65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173194" y="1711256"/>
            <a:ext cx="955806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CARS regulate expression of a majority of 13,824  genes associated with HSRS</a:t>
            </a:r>
          </a:p>
        </p:txBody>
      </p:sp>
    </p:spTree>
    <p:extLst>
      <p:ext uri="{BB962C8B-B14F-4D97-AF65-F5344CB8AC3E}">
        <p14:creationId xmlns:p14="http://schemas.microsoft.com/office/powerpoint/2010/main" val="13278425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381719" y="307778"/>
          <a:ext cx="3319012" cy="31802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1858"/>
                <a:gridCol w="922570"/>
                <a:gridCol w="888977"/>
                <a:gridCol w="655607"/>
              </a:tblGrid>
              <a:tr h="2643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YPE OF CANC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ANCER SURVIVAL GENE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HERVH-REGULATE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ERCEN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BREAS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8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2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9.3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ROSTAT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6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9.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ANCREATIC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54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2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0.6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IV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89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26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3.8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REN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7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57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2.4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OLORECT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6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3.4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ERVIC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1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3.5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UNG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6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9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5.0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HYROI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4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5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4.0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OVARIA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0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0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0.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ENDOMETRI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63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5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9.9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UROTHELI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10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5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1.6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HEAD &amp; NECK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8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4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2.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GLIOM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1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2.4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MEANOM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0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8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1.4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STOMACH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0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4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6.9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ESTI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8.3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  <a:tr h="13513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ALL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07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43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</a:rPr>
                        <a:t>41.4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2" marR="6962" marT="6962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41539" y="1"/>
            <a:ext cx="367363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HERVH lncRNA-regulated cancer survival genes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4431821" y="307777"/>
          <a:ext cx="3319012" cy="31927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0471"/>
                <a:gridCol w="940292"/>
                <a:gridCol w="871268"/>
                <a:gridCol w="646981"/>
              </a:tblGrid>
              <a:tr h="20246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YPE OF CANC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ANCER SURVIVAL GENE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TR7Y/B-REGULATE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ERCEN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BREAS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8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8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8.8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ROSTAT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6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9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5.9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ANCREATIC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54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7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9.8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IV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89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56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4.1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REN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7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88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7.4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OLORECT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3.0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ERVIC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4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7.4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UNG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6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1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7.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HYROI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4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9.2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OVARIA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0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3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6.2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ENDOMETRI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63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4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5.8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UROTHELI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10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8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3.8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HEAD &amp; NECK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8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6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5.6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GLIOM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2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7.2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MEANOM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0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0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2.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STOMACH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0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3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2.6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ESTI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3.3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079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ALL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07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0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</a:rPr>
                        <a:t>46.79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4506373" y="1"/>
            <a:ext cx="316990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LTR7Y/B-regulated cancer survival genes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8481923" y="307777"/>
          <a:ext cx="3319012" cy="31927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43232"/>
                <a:gridCol w="948905"/>
                <a:gridCol w="879895"/>
                <a:gridCol w="646980"/>
              </a:tblGrid>
              <a:tr h="3077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TYPE OF CANC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CANCER SURVIVAL GENES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LTR5_Hs/SVA_D-REGULATED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PERCENT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BREAST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582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8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3.75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PROSTATE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6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6.2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PANCREATIC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49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25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6.1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LIVER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2892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382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3.2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RENAL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607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965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.9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COLORECTAL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603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0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17.2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CERVICAL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717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12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.62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LUNG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662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05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.86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THYROID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347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56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6.1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OVARIAN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50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78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.48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ENDOMETRIAL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63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25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.33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UROTHELIAL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10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6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4.9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HEAD &amp; NECK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808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28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5.8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GLIOMA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27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48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7.7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MEANOMA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205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2.2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STOMACH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307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8.14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TESTIS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60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8.33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95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ALL 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0713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solidFill>
                            <a:schemeClr val="tx1"/>
                          </a:solidFill>
                          <a:effectLst/>
                        </a:rPr>
                        <a:t>1641</a:t>
                      </a:r>
                      <a:endParaRPr lang="en-US" sz="1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15.32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/>
          </p:nvPr>
        </p:nvGraphicFramePr>
        <p:xfrm>
          <a:off x="3700731" y="3795833"/>
          <a:ext cx="4781193" cy="30403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60920"/>
                <a:gridCol w="1506570"/>
                <a:gridCol w="1155939"/>
                <a:gridCol w="657764"/>
              </a:tblGrid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YPE OF CANC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ANCER SURVIVAL GENE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SCARS-REGULATE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ERCEN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BREAS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8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0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9.5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ROSTAT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6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2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5.1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PANCREATIC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54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11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1.7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IV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89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2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6.6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REN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7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40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2.5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OLORECT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4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4.3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CERVIC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2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3.3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LUNG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6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8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3.7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HYROI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4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5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4.6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OVARIAN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0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6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3.0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ENDOMETRI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63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12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9.2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UROTHELI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10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7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0.1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HEAD &amp; NECK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80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55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9.0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GLIOM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7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0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5.2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MEANOMA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0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4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2.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STOMACH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30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21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1.3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TESTI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4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68.3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2929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ALL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1071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</a:rPr>
                        <a:t>760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</a:rPr>
                        <a:t>71.0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8" name="Rectangle 7"/>
          <p:cNvSpPr/>
          <p:nvPr/>
        </p:nvSpPr>
        <p:spPr>
          <a:xfrm>
            <a:off x="1431984" y="3474888"/>
            <a:ext cx="948905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/>
              <a:t>SCARS REGULATE EXPRESSION OF A PROMINENT MAJORITY OF HUMAN CANCER SURVIVAL PREDICTOR GENES</a:t>
            </a:r>
          </a:p>
        </p:txBody>
      </p:sp>
      <p:sp>
        <p:nvSpPr>
          <p:cNvPr id="9" name="Rectangle 8"/>
          <p:cNvSpPr/>
          <p:nvPr/>
        </p:nvSpPr>
        <p:spPr>
          <a:xfrm>
            <a:off x="8223739" y="-6584"/>
            <a:ext cx="383537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LTR5_Hs/SVA_D-regulated cancer survival genes</a:t>
            </a:r>
          </a:p>
        </p:txBody>
      </p:sp>
    </p:spTree>
    <p:extLst>
      <p:ext uri="{BB962C8B-B14F-4D97-AF65-F5344CB8AC3E}">
        <p14:creationId xmlns:p14="http://schemas.microsoft.com/office/powerpoint/2010/main" val="29662254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0166" y="1122363"/>
            <a:ext cx="11757804" cy="23876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SCARS regulate expression of a prominent majority of cancer driver gene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57068" y="3912589"/>
            <a:ext cx="9144000" cy="1228754"/>
          </a:xfrm>
        </p:spPr>
        <p:txBody>
          <a:bodyPr>
            <a:normAutofit fontScale="92500" lnSpcReduction="10000"/>
          </a:bodyPr>
          <a:lstStyle/>
          <a:p>
            <a:r>
              <a:rPr lang="en-US" dirty="0" smtClean="0"/>
              <a:t>460 CANCER DRIVER GENES</a:t>
            </a:r>
          </a:p>
          <a:p>
            <a:r>
              <a:rPr lang="en-US" dirty="0"/>
              <a:t>Identification of cancer driver genes based on nucleotide context. </a:t>
            </a:r>
          </a:p>
          <a:p>
            <a:r>
              <a:rPr lang="en-US" dirty="0" err="1"/>
              <a:t>Dietlein</a:t>
            </a:r>
            <a:r>
              <a:rPr lang="en-US" dirty="0"/>
              <a:t> F, et al. Nat Genet. 2020. Nat Genet. 52: 208-218. </a:t>
            </a:r>
            <a:endParaRPr lang="en-US" dirty="0" smtClean="0"/>
          </a:p>
          <a:p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18744492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9837638"/>
              </p:ext>
            </p:extLst>
          </p:nvPr>
        </p:nvGraphicFramePr>
        <p:xfrm>
          <a:off x="258790" y="698115"/>
          <a:ext cx="11637033" cy="121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17666"/>
                <a:gridCol w="5548900"/>
                <a:gridCol w="1861229"/>
                <a:gridCol w="2218776"/>
                <a:gridCol w="590462"/>
              </a:tblGrid>
              <a:tr h="1292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+mn-lt"/>
                        </a:rPr>
                        <a:t>Category of cancer driver gen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Peer-review literature support leve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Number of cancer driver gen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SCARS-regulated cancer driver gen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Percen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</a:tr>
              <a:tr h="1292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level 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Genes listed in the Cancer Gene Censu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19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14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74.7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</a:tr>
              <a:tr h="1294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level 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Genes with literature support in the same tumor types as those identified by NG2020 metho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9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6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68.89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</a:tr>
              <a:tr h="1292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level 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Genes with literature support in a different tumor typ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98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6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65.3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</a:tr>
              <a:tr h="1292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level 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Genes with no literature suppor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78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3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43.59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</a:tr>
              <a:tr h="1292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+mn-lt"/>
                        </a:rPr>
                        <a:t>All cancer driver gen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+mn-lt"/>
                        </a:rPr>
                        <a:t>46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+mn-lt"/>
                        </a:rPr>
                        <a:t>305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+mn-lt"/>
                        </a:rPr>
                        <a:t>66.3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670" marR="6670" marT="6670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58785" y="182201"/>
            <a:ext cx="11637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SCARS regulate expression of a prominent majority of high-confidence cancer driver </a:t>
            </a:r>
            <a:r>
              <a:rPr lang="en-US" sz="1400" b="1" dirty="0" smtClean="0"/>
              <a:t>genes defined by </a:t>
            </a:r>
          </a:p>
          <a:p>
            <a:pPr algn="ctr"/>
            <a:r>
              <a:rPr lang="en-US" sz="1400" b="1" dirty="0" smtClean="0"/>
              <a:t>different levels of peer-review literature support</a:t>
            </a:r>
            <a:endParaRPr lang="en-US" sz="14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7273793"/>
              </p:ext>
            </p:extLst>
          </p:nvPr>
        </p:nvGraphicFramePr>
        <p:xfrm>
          <a:off x="258789" y="2841926"/>
          <a:ext cx="5279369" cy="12573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61975"/>
                <a:gridCol w="1102091"/>
                <a:gridCol w="1315398"/>
                <a:gridCol w="799905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Minimum FDR cut-off leve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umber of cancer driver gen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SCARS-regulated cancer driver gen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Percent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0 to &lt;0.00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178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13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73.0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&gt;0.001 to &lt;0.0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9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6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67.7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&gt;0.05 to &lt;0.15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9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58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63.7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&gt;0.15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98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5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55.1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All cancer driver gene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460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30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66.3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58789" y="2105141"/>
            <a:ext cx="527936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SCARS regulate expression of a prominent majority of </a:t>
            </a:r>
            <a:endParaRPr lang="en-US" sz="1400" b="1" dirty="0" smtClean="0"/>
          </a:p>
          <a:p>
            <a:pPr algn="ctr"/>
            <a:r>
              <a:rPr lang="en-US" sz="1400" b="1" dirty="0" smtClean="0"/>
              <a:t>high-confidence </a:t>
            </a:r>
            <a:r>
              <a:rPr lang="en-US" sz="1400" b="1" dirty="0"/>
              <a:t>cancer driver </a:t>
            </a:r>
            <a:r>
              <a:rPr lang="en-US" sz="1400" b="1" dirty="0" smtClean="0"/>
              <a:t>genes defined by </a:t>
            </a:r>
          </a:p>
          <a:p>
            <a:pPr algn="ctr"/>
            <a:r>
              <a:rPr lang="en-US" sz="1400" b="1" dirty="0" smtClean="0"/>
              <a:t>different levels of statistical significance</a:t>
            </a:r>
            <a:endParaRPr lang="en-US" sz="1400" b="1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5786583"/>
              </p:ext>
            </p:extLst>
          </p:nvPr>
        </p:nvGraphicFramePr>
        <p:xfrm>
          <a:off x="2273060" y="4917125"/>
          <a:ext cx="8333118" cy="1524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31342"/>
                <a:gridCol w="2170434"/>
                <a:gridCol w="2330565"/>
                <a:gridCol w="1300777"/>
              </a:tblGrid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Max. Mutation </a:t>
                      </a:r>
                      <a:r>
                        <a:rPr lang="en-US" sz="1200" b="1" u="none" strike="noStrike" dirty="0" smtClean="0">
                          <a:effectLst/>
                        </a:rPr>
                        <a:t>Frequency  </a:t>
                      </a:r>
                      <a:r>
                        <a:rPr lang="en-US" sz="1200" b="1" u="none" strike="noStrike" dirty="0">
                          <a:effectLst/>
                        </a:rPr>
                        <a:t>(%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Number of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SCARS-regulated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Percent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&gt; 50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83.3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&gt;=20% to &lt;50%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2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5.0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&gt;=10% to &lt;20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5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4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71.4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&gt;=5% to &lt;10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9.8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&gt;=3% to &lt;5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6.6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% to 2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8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1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62.37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565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All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46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30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6.3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2273060" y="4408516"/>
            <a:ext cx="833311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SCARS regulate expression of a prominent majority of cancer driver </a:t>
            </a:r>
            <a:r>
              <a:rPr lang="en-US" sz="1400" b="1" dirty="0" smtClean="0"/>
              <a:t>genes defined by </a:t>
            </a:r>
          </a:p>
          <a:p>
            <a:pPr algn="ctr"/>
            <a:r>
              <a:rPr lang="en-US" sz="1400" b="1" dirty="0" smtClean="0"/>
              <a:t>different levels of mutation frequency</a:t>
            </a:r>
            <a:endParaRPr lang="en-US" sz="1400" b="1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4408817"/>
              </p:ext>
            </p:extLst>
          </p:nvPr>
        </p:nvGraphicFramePr>
        <p:xfrm>
          <a:off x="5883214" y="2843804"/>
          <a:ext cx="6012609" cy="125542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91282"/>
                <a:gridCol w="1212154"/>
                <a:gridCol w="1509173"/>
              </a:tblGrid>
              <a:tr h="4128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lassification categor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Number of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Percent of all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106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</a:rPr>
                        <a:t>HERV-H-regulated </a:t>
                      </a:r>
                      <a:r>
                        <a:rPr lang="en-US" sz="1200" b="1" u="none" strike="noStrike" dirty="0">
                          <a:effectLst/>
                        </a:rPr>
                        <a:t>cancer driver gene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8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40.2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106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LTR7Y/B-regulated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9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42.3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106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LTR5_Hs/SVA_D-regulated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19.7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106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All SCARS-regulated cancer driver gene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305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6.3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5857333" y="2105141"/>
            <a:ext cx="601261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Distinct families of SCARS </a:t>
            </a:r>
            <a:r>
              <a:rPr lang="en-US" sz="1400" b="1" dirty="0"/>
              <a:t>regulate </a:t>
            </a:r>
            <a:r>
              <a:rPr lang="en-US" sz="1400" b="1" dirty="0" smtClean="0"/>
              <a:t>expression </a:t>
            </a:r>
            <a:r>
              <a:rPr lang="en-US" sz="1400" b="1" dirty="0"/>
              <a:t>of cancer driver </a:t>
            </a:r>
            <a:r>
              <a:rPr lang="en-US" sz="1400" b="1" dirty="0" smtClean="0"/>
              <a:t>genes collectively affecting expression of a prominent majority </a:t>
            </a:r>
          </a:p>
          <a:p>
            <a:pPr algn="ctr"/>
            <a:r>
              <a:rPr lang="en-US" sz="1400" b="1" dirty="0" smtClean="0"/>
              <a:t>of cancer driver genes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627916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3509428"/>
              </p:ext>
            </p:extLst>
          </p:nvPr>
        </p:nvGraphicFramePr>
        <p:xfrm>
          <a:off x="301926" y="835286"/>
          <a:ext cx="11369614" cy="578432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22232"/>
                <a:gridCol w="3847382"/>
              </a:tblGrid>
              <a:tr h="1694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ancer Typ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Number of </a:t>
                      </a:r>
                      <a:r>
                        <a:rPr lang="en-US" sz="1200" b="1" u="none" strike="noStrike" dirty="0" smtClean="0">
                          <a:effectLst/>
                        </a:rPr>
                        <a:t>SCARS-activated </a:t>
                      </a:r>
                      <a:r>
                        <a:rPr lang="en-US" sz="1200" b="1" u="none" strike="noStrike" dirty="0">
                          <a:effectLst/>
                        </a:rPr>
                        <a:t>cancer driver gene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AdenoidCysti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lad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loo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ra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Brea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ervix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Cholangio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Colorect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Endometriu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Gastroesophagea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HeadNeck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KidneyClea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KidneyNonClea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Liv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Lung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LungS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Lymph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Ovaria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ancrea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Pheochromocytom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rostat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Sarcom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Sk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TesticularGermCel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Thymu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Thyro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effectLst/>
                        </a:rPr>
                        <a:t>UvealMelanom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  <a:tr h="1606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umber of actionable cancer therapy-guiding nodes defined by the SCARS </a:t>
                      </a:r>
                      <a:r>
                        <a:rPr lang="en-US" sz="1600" b="1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emness</a:t>
                      </a:r>
                      <a:r>
                        <a:rPr lang="en-US" sz="16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atrix mapped to connect Cancer Driver Gene/Cancer Type/Regulatory SCARS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834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69" marR="6069" marT="6069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301926" y="188955"/>
            <a:ext cx="1130060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SCARS-guided cancer </a:t>
            </a:r>
            <a:r>
              <a:rPr lang="en-US" b="1" dirty="0" err="1"/>
              <a:t>stemness</a:t>
            </a:r>
            <a:r>
              <a:rPr lang="en-US" b="1" dirty="0"/>
              <a:t> matrix of diagnostic and therapeutic targets comprising of 141 </a:t>
            </a:r>
            <a:r>
              <a:rPr lang="en-US" b="1" dirty="0" smtClean="0"/>
              <a:t>SCARS-activated </a:t>
            </a:r>
            <a:r>
              <a:rPr lang="en-US" b="1" dirty="0"/>
              <a:t>cancer driver genes mapped to 27 cancer types</a:t>
            </a:r>
          </a:p>
        </p:txBody>
      </p:sp>
    </p:spTree>
    <p:extLst>
      <p:ext uri="{BB962C8B-B14F-4D97-AF65-F5344CB8AC3E}">
        <p14:creationId xmlns:p14="http://schemas.microsoft.com/office/powerpoint/2010/main" val="1386508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1412</Words>
  <Application>Microsoft Office PowerPoint</Application>
  <PresentationFormat>Widescreen</PresentationFormat>
  <Paragraphs>718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Supplemental Note S4. HSRS and SCARS regulate expression of a vast majority of cancer survival predictor genes and cancer driver genes</vt:lpstr>
      <vt:lpstr>HSRS and SCARS regulate expression of cancer survival predictor genes</vt:lpstr>
      <vt:lpstr>PowerPoint Presentation</vt:lpstr>
      <vt:lpstr>PowerPoint Presentation</vt:lpstr>
      <vt:lpstr>PowerPoint Presentation</vt:lpstr>
      <vt:lpstr>PowerPoint Presentation</vt:lpstr>
      <vt:lpstr>SCARS regulate expression of a prominent majority of cancer driver gene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SRS and SCARS regulate expression of cancer survival predictor genes and can cer driver genes</dc:title>
  <dc:creator>Guennadi Glinskii</dc:creator>
  <cp:lastModifiedBy>Guennadi Glinskii</cp:lastModifiedBy>
  <cp:revision>16</cp:revision>
  <dcterms:created xsi:type="dcterms:W3CDTF">2020-06-08T09:13:21Z</dcterms:created>
  <dcterms:modified xsi:type="dcterms:W3CDTF">2021-03-23T20:58:31Z</dcterms:modified>
</cp:coreProperties>
</file>